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706" autoAdjust="0"/>
    <p:restoredTop sz="94660"/>
  </p:normalViewPr>
  <p:slideViewPr>
    <p:cSldViewPr showGuides="1">
      <p:cViewPr>
        <p:scale>
          <a:sx n="134" d="100"/>
          <a:sy n="134" d="100"/>
        </p:scale>
        <p:origin x="-304" y="-56"/>
      </p:cViewPr>
      <p:guideLst>
        <p:guide orient="horz" pos="864"/>
        <p:guide orient="horz" pos="2016"/>
        <p:guide orient="horz" pos="720"/>
        <p:guide orient="horz" pos="2928"/>
        <p:guide orient="horz" pos="3072"/>
        <p:guide orient="horz" pos="144"/>
        <p:guide pos="5232"/>
        <p:guide pos="96"/>
        <p:guide pos="1680"/>
        <p:guide pos="32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3D44F7-B09D-443A-B1EF-8D33CD2A03E8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58CF78-18B7-4249-BA17-4BE1712C4B3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207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358CF78-18B7-4249-BA17-4BE1712C4B34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FED641-85BE-4E25-A590-32B017502A03}" type="datetimeFigureOut">
              <a:rPr lang="en-US" smtClean="0"/>
              <a:pPr/>
              <a:t>01/0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CC3A20-6D27-407D-8359-981F4956D33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Rectangle 1"/>
          <p:cNvSpPr>
            <a:spLocks noChangeArrowheads="1"/>
          </p:cNvSpPr>
          <p:nvPr/>
        </p:nvSpPr>
        <p:spPr bwMode="auto">
          <a:xfrm>
            <a:off x="152400" y="228600"/>
            <a:ext cx="8879354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orting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able S1.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scription of reference genes, Arabidopsis Gene Index (AGI)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orthologous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identifiers and blueberry primer sequences.</a:t>
            </a:r>
            <a:r>
              <a:rPr lang="en-US" sz="1100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Primer PCR efficiency and PCR Tm product data represent mean values ± SE.</a:t>
            </a:r>
            <a:r>
              <a:rPr lang="en-US" sz="11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PCR efficiencies (E) calculated according to the equation (1 + E) = 10</a:t>
            </a:r>
            <a:r>
              <a:rPr lang="en-US" sz="1100" baseline="300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lope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52400" y="683020"/>
          <a:ext cx="8686801" cy="5034760"/>
        </p:xfrm>
        <a:graphic>
          <a:graphicData uri="http://schemas.openxmlformats.org/drawingml/2006/table">
            <a:tbl>
              <a:tblPr/>
              <a:tblGrid>
                <a:gridCol w="685800"/>
                <a:gridCol w="609600"/>
                <a:gridCol w="1676400"/>
                <a:gridCol w="609600"/>
                <a:gridCol w="533400"/>
                <a:gridCol w="609600"/>
                <a:gridCol w="2286000"/>
                <a:gridCol w="609600"/>
                <a:gridCol w="457200"/>
                <a:gridCol w="609601"/>
              </a:tblGrid>
              <a:tr h="8120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Id Blueberry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AGI code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Annotation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Sequence Identity (amino acid) between the 2 species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E value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Reported by </a:t>
                      </a:r>
                      <a:r>
                        <a:rPr lang="en-US" sz="800" dirty="0" err="1">
                          <a:latin typeface="Times New Roman"/>
                          <a:ea typeface="Calibri"/>
                          <a:cs typeface="Times New Roman"/>
                        </a:rPr>
                        <a:t>Czechowski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 et al (2005)?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Primer Sequence (5’-3’)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PCR E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PCR product size (</a:t>
                      </a:r>
                      <a:r>
                        <a:rPr lang="en-US" sz="800" dirty="0" err="1">
                          <a:latin typeface="Times New Roman"/>
                          <a:ea typeface="Calibri"/>
                          <a:cs typeface="Times New Roman"/>
                        </a:rPr>
                        <a:t>bp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)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Times New Roman"/>
                        </a:rPr>
                        <a:t>PCR product Tm (°C)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ontig00988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4g3427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IP41-like protein (</a:t>
                      </a:r>
                      <a:r>
                        <a:rPr lang="en-US" sz="800" i="1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IP41</a:t>
                      </a: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65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2e-076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Yes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-TGC CAA GTT CAT GGT TTG TTC T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CAT ACG CGT GTC TCT CAA TCT CA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7±0.0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9.56±0.04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ontig11436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5g2576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 err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ubiquitin-conjugating</a:t>
                      </a:r>
                      <a:r>
                        <a:rPr lang="es-E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800" dirty="0" err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enzyme</a:t>
                      </a:r>
                      <a:r>
                        <a:rPr lang="es-E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E2 (</a:t>
                      </a:r>
                      <a:r>
                        <a:rPr lang="es-ES" sz="800" i="1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EX4</a:t>
                      </a:r>
                      <a:r>
                        <a:rPr lang="es-E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94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1e-086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Yes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-CAC TCA ATT GTG ATT CAG GCA ATC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CTT AGT GTA CAT CCT TGC CAT GGA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2±0.03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9.97±0.03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ontig0838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4g2641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hypothetical protein (</a:t>
                      </a:r>
                      <a:r>
                        <a:rPr lang="en-US" sz="800" i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Vc4g26410</a:t>
                      </a: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61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>
                          <a:latin typeface="Times New Roman" pitchFamily="18" charset="0"/>
                          <a:cs typeface="Times New Roman" pitchFamily="18" charset="0"/>
                        </a:rPr>
                        <a:t>4e-07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Ye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-GCG AGG CAA GTG GTA TAA TGG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GAT TTG GTG ATT GCG CTT GTT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09±0.0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5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1.0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pPr marL="0" marR="0" indent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ontig13407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4g1632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unknown protein (</a:t>
                      </a:r>
                      <a:r>
                        <a:rPr lang="en-US" sz="800" i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Vc4g16320</a:t>
                      </a: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>
                          <a:latin typeface="Times New Roman" pitchFamily="18" charset="0"/>
                          <a:cs typeface="Times New Roman" pitchFamily="18" charset="0"/>
                        </a:rPr>
                        <a:t>57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5e-04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Ye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-CCA TTG ATA GAT GGC AAT CTC AAG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CTC CTC GTC CCT TAT CTG CAT AG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1±0.0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1.22±0.06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ontig13673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4g2796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SUMO-conjugating enzyme (</a:t>
                      </a:r>
                      <a:r>
                        <a:rPr lang="en-US" sz="800" i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UBC9</a:t>
                      </a: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96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2e-084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Ye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-TGA CGG ATC CAA ACC CTG AT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CAT ACT TGG CCT TAT CCG TCT TG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00±0.0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5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1.5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ontig10818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4g3807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asic helix-loop-helix domain-containing protein (</a:t>
                      </a:r>
                      <a:r>
                        <a:rPr lang="en-US" sz="800" i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bHLH</a:t>
                      </a: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6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1e-017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Ye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-CCA ATG CCA TAG CGA TAA TCC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GGC TTG GCT ATG GTT CCT AGA A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8±0.0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5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0.38±0.06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ontig10759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5g1571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-box/kelch-repeat protein (</a:t>
                      </a:r>
                      <a:r>
                        <a:rPr lang="en-US" sz="800" i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box</a:t>
                      </a: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8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1e-127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Ye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-GGA TGG ATC GGT CGT TTA AAA TT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CCA ACA GTC AAG CTT CGA ATC AT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9±0.0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95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9.56±0.04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ontig14463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1g1344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glyceraldehyde 3-phosphate dehydrogenase (</a:t>
                      </a:r>
                      <a:r>
                        <a:rPr lang="en-US" sz="800" i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GAPDH</a:t>
                      </a: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4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>
                          <a:latin typeface="Times New Roman" pitchFamily="18" charset="0"/>
                          <a:cs typeface="Times New Roman" pitchFamily="18" charset="0"/>
                        </a:rPr>
                        <a:t>1e-161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Ye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-CGG CTA CTT ACG AGC AAA TCA A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TTC AGT GTA GCC CAA AAT TCC TTT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7±0.01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9.78±0.06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ontig04475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1g6293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entatricopeptide repeat-containing protein (</a:t>
                      </a:r>
                      <a:r>
                        <a:rPr lang="en-US" sz="800" i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PR</a:t>
                      </a: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0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>
                          <a:latin typeface="Times New Roman" pitchFamily="18" charset="0"/>
                          <a:cs typeface="Times New Roman" pitchFamily="18" charset="0"/>
                        </a:rPr>
                        <a:t>1e-07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Ye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-CTC CAG AGG AGT TGT GAG GAA AG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GGC CAC AAA TAT CCC AAA AAC TAC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0±0.0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5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1.06±0.04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r>
                        <a:rPr lang="en-US" sz="800">
                          <a:latin typeface="Times New Roman" pitchFamily="18" charset="0"/>
                          <a:cs typeface="Times New Roman" pitchFamily="18" charset="0"/>
                        </a:rPr>
                        <a:t>contig0537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5g46630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lathrin adapter complexes medium subunit (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ACSa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93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>
                          <a:latin typeface="Times New Roman" pitchFamily="18" charset="0"/>
                          <a:cs typeface="Times New Roman" pitchFamily="18" charset="0"/>
                        </a:rPr>
                        <a:t>6e-068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Yes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*F-TTG GAT GGC GAA GAG AGG GTC TT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 CCC AAC TTC AAA TCA GGC ATT CCA G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8±0.04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69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0.5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r>
                        <a:rPr lang="en-US" sz="800">
                          <a:latin typeface="Times New Roman" pitchFamily="18" charset="0"/>
                          <a:cs typeface="Times New Roman" pitchFamily="18" charset="0"/>
                        </a:rPr>
                        <a:t>contig13874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1g64230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Ubiquitin-conjugating enzyme (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UBC28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92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>
                          <a:latin typeface="Times New Roman" pitchFamily="18" charset="0"/>
                          <a:cs typeface="Times New Roman" pitchFamily="18" charset="0"/>
                        </a:rPr>
                        <a:t>2e-081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o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*F-CCA TCC ACT TCC CTC CAG ATT ATC CAT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ACA GAT TGA GAG CAG CAC CTT GGA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10± 0.0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64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2.47±0.03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r>
                        <a:rPr lang="en-US" sz="800">
                          <a:latin typeface="Times New Roman" pitchFamily="18" charset="0"/>
                          <a:cs typeface="Times New Roman" pitchFamily="18" charset="0"/>
                        </a:rPr>
                        <a:t>contig11743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endParaRPr lang="en-US" sz="8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5g03240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olyubiquitin(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UBQ3b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95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1e-081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o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*F-CCT CCA CTT GGT GCT CCG T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AGA TGA GCC TCT GCT GAT CCG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9±0.03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64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4.70±0.08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82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8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tig00187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4g00660</a:t>
                      </a:r>
                      <a:endParaRPr lang="en-US" sz="8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NA helicase-like (</a:t>
                      </a:r>
                      <a:r>
                        <a:rPr lang="en-US" sz="8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H8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95%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itchFamily="18" charset="0"/>
                          <a:cs typeface="Times New Roman" pitchFamily="18" charset="0"/>
                        </a:rPr>
                        <a:t>1e-121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o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*F-GGT GAA TCG AGT AGA ACT GCT GGC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-AGA TTC CTG CAT GCA CCA TTC CGA</a:t>
                      </a:r>
                      <a:endParaRPr lang="en-US" sz="8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9±0.02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35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1.50</a:t>
                      </a:r>
                    </a:p>
                  </a:txBody>
                  <a:tcPr marL="45863" marR="458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152400" y="5791200"/>
            <a:ext cx="876300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52400" y="5799638"/>
            <a:ext cx="8879354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1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* Primer pairs designed by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Vashisth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et al [40]</a:t>
            </a:r>
            <a:endParaRPr kumimoji="0" lang="en-US" sz="11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8</TotalTime>
  <Words>656</Words>
  <Application>Microsoft Macintosh PowerPoint</Application>
  <PresentationFormat>On-screen Show (4:3)</PresentationFormat>
  <Paragraphs>15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ieJ</dc:creator>
  <cp:lastModifiedBy>Rodrigo Rato</cp:lastModifiedBy>
  <cp:revision>61</cp:revision>
  <dcterms:created xsi:type="dcterms:W3CDTF">2013-04-05T15:48:16Z</dcterms:created>
  <dcterms:modified xsi:type="dcterms:W3CDTF">2013-08-01T13:55:23Z</dcterms:modified>
</cp:coreProperties>
</file>